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2" d="100"/>
          <a:sy n="112" d="100"/>
        </p:scale>
        <p:origin x="-1884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831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949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257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867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180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249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208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309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649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734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922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B6E86-51AB-47E7-803B-13DDB39DC793}" type="datetimeFigureOut">
              <a:rPr lang="en-US" smtClean="0"/>
              <a:t>11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5278CE-8D47-4566-91A3-936E33384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564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33400" y="1931192"/>
            <a:ext cx="8229600" cy="2412208"/>
            <a:chOff x="381000" y="3836192"/>
            <a:chExt cx="8229600" cy="2412208"/>
          </a:xfrm>
        </p:grpSpPr>
        <p:pic>
          <p:nvPicPr>
            <p:cNvPr id="7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680" b="895"/>
            <a:stretch/>
          </p:blipFill>
          <p:spPr bwMode="auto">
            <a:xfrm>
              <a:off x="381000" y="3836192"/>
              <a:ext cx="8229600" cy="241220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381000" y="5334000"/>
              <a:ext cx="1298304" cy="27699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CMA log</a:t>
              </a:r>
              <a:r>
                <a:rPr lang="en-US" sz="1200" baseline="-25000" dirty="0" smtClean="0"/>
                <a:t>2</a:t>
              </a:r>
              <a:r>
                <a:rPr lang="en-US" sz="1200" dirty="0" smtClean="0"/>
                <a:t>R results</a:t>
              </a:r>
              <a:endParaRPr lang="en-US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81000" y="5971401"/>
              <a:ext cx="1914563" cy="27699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Genes in the deleted region</a:t>
              </a:r>
              <a:endParaRPr lang="en-US" sz="1200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457200" y="543176"/>
            <a:ext cx="8305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gure 1.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genomi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croarray analysis (CMA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sults of VI.3 with HLHS using Agilent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GXChi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+ SNP v1.0 4x180K array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deletion detect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VI.3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as a 1.76 Mb deletion of chromosome 6q24.3-q25.1 ([hg19] chr6:148684028-150448233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inherited from his mother (III.5).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xis:  log</a:t>
            </a:r>
            <a:r>
              <a:rPr lang="en-US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Ratio.  Y axis:  genomic location.  Non-mosaic one-copy deletions have log</a:t>
            </a:r>
            <a:r>
              <a:rPr lang="en-US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 </a:t>
            </a:r>
            <a:r>
              <a:rPr lang="en-US" sz="1200" dirty="0" smtClean="0"/>
              <a:t>=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UCSC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s in the delet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gio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4337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1</TotalTime>
  <Words>86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Washing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juan Jane Liu</dc:creator>
  <cp:lastModifiedBy>Yajuan Jane Liu</cp:lastModifiedBy>
  <cp:revision>8</cp:revision>
  <dcterms:created xsi:type="dcterms:W3CDTF">2019-11-11T02:23:08Z</dcterms:created>
  <dcterms:modified xsi:type="dcterms:W3CDTF">2019-11-11T22:00:25Z</dcterms:modified>
</cp:coreProperties>
</file>